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E90476-D22E-4E91-B84A-90BA7C703E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936E1-002D-4A63-9F4F-6D923544BC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5AB265-63FF-4120-8C53-DD2CEE0CA2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5E41C-D25E-48AB-B61A-92C1C0349D3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835FF-4B2D-423B-A580-2CAAC2A723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D98F3C-E8D2-4D85-880A-30DFB154EA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E8D75-F83C-478D-A22A-72630A2850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4E39B-1285-4057-875F-458E3C9A60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8414B4-7B77-474C-B10A-FEEFAA49B0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59AFE-574E-44E8-9DE7-6F3232DFD7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AB071-EA71-4223-B9DB-C9990AA63D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E48BA5-FB9E-4D70-874E-841F7A05F0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F843774-68FC-49D4-96A1-360CAEB21E91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829A094-CD3C-4830-AFB1-D3D7A45FCA96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957480" y="803160"/>
            <a:ext cx="4308480" cy="6008760"/>
            <a:chOff x="3957480" y="803160"/>
            <a:chExt cx="4308480" cy="6008760"/>
          </a:xfrm>
        </p:grpSpPr>
        <p:pic>
          <p:nvPicPr>
            <p:cNvPr id="42" name="Bild 3" descr="IT2.jpg"/>
            <p:cNvPicPr/>
            <p:nvPr/>
          </p:nvPicPr>
          <p:blipFill>
            <a:blip r:embed="rId1"/>
            <a:stretch/>
          </p:blipFill>
          <p:spPr>
            <a:xfrm>
              <a:off x="3957480" y="803160"/>
              <a:ext cx="4308480" cy="6008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Oval 4"/>
            <p:cNvSpPr/>
            <p:nvPr/>
          </p:nvSpPr>
          <p:spPr>
            <a:xfrm>
              <a:off x="5957640" y="369864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feld 5"/>
            <p:cNvSpPr/>
            <p:nvPr/>
          </p:nvSpPr>
          <p:spPr>
            <a:xfrm>
              <a:off x="5988960" y="353664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Calibri"/>
                </a:rPr>
                <a:t>Rome</a:t>
              </a:r>
              <a:r>
                <a:rPr b="0" lang="de-DE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Oval 6"/>
            <p:cNvSpPr/>
            <p:nvPr/>
          </p:nvSpPr>
          <p:spPr>
            <a:xfrm>
              <a:off x="5290920" y="297324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feld 7"/>
            <p:cNvSpPr/>
            <p:nvPr/>
          </p:nvSpPr>
          <p:spPr>
            <a:xfrm>
              <a:off x="5271840" y="2814480"/>
              <a:ext cx="45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Calibri"/>
                </a:rPr>
                <a:t>Pisa</a:t>
              </a:r>
              <a:r>
                <a:rPr b="0" lang="de-DE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Oval 8"/>
            <p:cNvSpPr/>
            <p:nvPr/>
          </p:nvSpPr>
          <p:spPr>
            <a:xfrm>
              <a:off x="5594040" y="239688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feld 9"/>
            <p:cNvSpPr/>
            <p:nvPr/>
          </p:nvSpPr>
          <p:spPr>
            <a:xfrm>
              <a:off x="5603040" y="2209680"/>
              <a:ext cx="61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Calibri"/>
                </a:rPr>
                <a:t>Mode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Oval 10"/>
            <p:cNvSpPr/>
            <p:nvPr/>
          </p:nvSpPr>
          <p:spPr>
            <a:xfrm>
              <a:off x="5445000" y="230328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feld 11"/>
            <p:cNvSpPr/>
            <p:nvPr/>
          </p:nvSpPr>
          <p:spPr>
            <a:xfrm>
              <a:off x="5240880" y="2087280"/>
              <a:ext cx="52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Calibri"/>
                </a:rPr>
                <a:t>Reggi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Oval 13"/>
            <p:cNvSpPr/>
            <p:nvPr/>
          </p:nvSpPr>
          <p:spPr>
            <a:xfrm>
              <a:off x="5484600" y="1576080"/>
              <a:ext cx="6012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feld 14"/>
            <p:cNvSpPr/>
            <p:nvPr/>
          </p:nvSpPr>
          <p:spPr>
            <a:xfrm>
              <a:off x="5466960" y="1419120"/>
              <a:ext cx="58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Calibri"/>
                </a:rPr>
                <a:t>Cembr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Oval 15"/>
            <p:cNvSpPr/>
            <p:nvPr/>
          </p:nvSpPr>
          <p:spPr>
            <a:xfrm>
              <a:off x="4776480" y="157320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feld 16"/>
            <p:cNvSpPr/>
            <p:nvPr/>
          </p:nvSpPr>
          <p:spPr>
            <a:xfrm>
              <a:off x="4787640" y="1385640"/>
              <a:ext cx="70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Calibri"/>
                </a:rPr>
                <a:t>Serentina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Oval 17"/>
            <p:cNvSpPr/>
            <p:nvPr/>
          </p:nvSpPr>
          <p:spPr>
            <a:xfrm>
              <a:off x="5481360" y="194292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feld 18"/>
            <p:cNvSpPr/>
            <p:nvPr/>
          </p:nvSpPr>
          <p:spPr>
            <a:xfrm>
              <a:off x="4983480" y="182088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Calibri"/>
                </a:rPr>
                <a:t>Vero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Oval 19"/>
            <p:cNvSpPr/>
            <p:nvPr/>
          </p:nvSpPr>
          <p:spPr>
            <a:xfrm>
              <a:off x="5519520" y="1366560"/>
              <a:ext cx="6012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feld 20"/>
            <p:cNvSpPr/>
            <p:nvPr/>
          </p:nvSpPr>
          <p:spPr>
            <a:xfrm>
              <a:off x="5176080" y="1139760"/>
              <a:ext cx="724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Feldthurn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Oval 21"/>
            <p:cNvSpPr/>
            <p:nvPr/>
          </p:nvSpPr>
          <p:spPr>
            <a:xfrm>
              <a:off x="6036840" y="1728720"/>
              <a:ext cx="604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feld 22"/>
            <p:cNvSpPr/>
            <p:nvPr/>
          </p:nvSpPr>
          <p:spPr>
            <a:xfrm>
              <a:off x="5662080" y="1761840"/>
              <a:ext cx="77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ordignan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hteck 23"/>
            <p:cNvSpPr/>
            <p:nvPr/>
          </p:nvSpPr>
          <p:spPr>
            <a:xfrm>
              <a:off x="5081040" y="1600200"/>
              <a:ext cx="104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Calibri"/>
                </a:rPr>
                <a:t>Farra di Soligno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Oval 24"/>
            <p:cNvSpPr/>
            <p:nvPr/>
          </p:nvSpPr>
          <p:spPr>
            <a:xfrm>
              <a:off x="5994000" y="1744560"/>
              <a:ext cx="604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Oval 25"/>
            <p:cNvSpPr/>
            <p:nvPr/>
          </p:nvSpPr>
          <p:spPr>
            <a:xfrm>
              <a:off x="7049880" y="140004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feld 26"/>
            <p:cNvSpPr/>
            <p:nvPr/>
          </p:nvSpPr>
          <p:spPr>
            <a:xfrm>
              <a:off x="7052040" y="1304640"/>
              <a:ext cx="74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Jareninski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Oval 27"/>
            <p:cNvSpPr/>
            <p:nvPr/>
          </p:nvSpPr>
          <p:spPr>
            <a:xfrm>
              <a:off x="6438600" y="169524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feld 28"/>
            <p:cNvSpPr/>
            <p:nvPr/>
          </p:nvSpPr>
          <p:spPr>
            <a:xfrm>
              <a:off x="6193800" y="1330200"/>
              <a:ext cx="8132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Kromberk*/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Nova Goric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Oval 29"/>
            <p:cNvSpPr/>
            <p:nvPr/>
          </p:nvSpPr>
          <p:spPr>
            <a:xfrm>
              <a:off x="6938640" y="169848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feld 30"/>
            <p:cNvSpPr/>
            <p:nvPr/>
          </p:nvSpPr>
          <p:spPr>
            <a:xfrm>
              <a:off x="6940440" y="1604880"/>
              <a:ext cx="52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Krško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Oval 31"/>
            <p:cNvSpPr/>
            <p:nvPr/>
          </p:nvSpPr>
          <p:spPr>
            <a:xfrm>
              <a:off x="6929280" y="1307880"/>
              <a:ext cx="5868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feld 32"/>
            <p:cNvSpPr/>
            <p:nvPr/>
          </p:nvSpPr>
          <p:spPr>
            <a:xfrm>
              <a:off x="5997960" y="1117440"/>
              <a:ext cx="1121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Deutschschützen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Oval 33"/>
            <p:cNvSpPr/>
            <p:nvPr/>
          </p:nvSpPr>
          <p:spPr>
            <a:xfrm>
              <a:off x="7181640" y="1261800"/>
              <a:ext cx="60120" cy="63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feld 34"/>
            <p:cNvSpPr/>
            <p:nvPr/>
          </p:nvSpPr>
          <p:spPr>
            <a:xfrm>
              <a:off x="7195320" y="116820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Calibri"/>
                </a:rPr>
                <a:t>Klöch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Oval 36"/>
            <p:cNvSpPr/>
            <p:nvPr/>
          </p:nvSpPr>
          <p:spPr>
            <a:xfrm>
              <a:off x="6474960" y="1841400"/>
              <a:ext cx="604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feld 37"/>
            <p:cNvSpPr/>
            <p:nvPr/>
          </p:nvSpPr>
          <p:spPr>
            <a:xfrm>
              <a:off x="6476040" y="1746000"/>
              <a:ext cx="636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Osevljek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Oval 39"/>
            <p:cNvSpPr/>
            <p:nvPr/>
          </p:nvSpPr>
          <p:spPr>
            <a:xfrm>
              <a:off x="7314840" y="1577880"/>
              <a:ext cx="604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feld 40"/>
            <p:cNvSpPr/>
            <p:nvPr/>
          </p:nvSpPr>
          <p:spPr>
            <a:xfrm>
              <a:off x="7314480" y="1482480"/>
              <a:ext cx="87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Zeljezna gor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Oval 41"/>
            <p:cNvSpPr/>
            <p:nvPr/>
          </p:nvSpPr>
          <p:spPr>
            <a:xfrm>
              <a:off x="4830480" y="1627200"/>
              <a:ext cx="604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Oval 42"/>
            <p:cNvSpPr/>
            <p:nvPr/>
          </p:nvSpPr>
          <p:spPr>
            <a:xfrm>
              <a:off x="4778280" y="1612800"/>
              <a:ext cx="58680" cy="633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feld 43"/>
            <p:cNvSpPr/>
            <p:nvPr/>
          </p:nvSpPr>
          <p:spPr>
            <a:xfrm>
              <a:off x="4820400" y="1538280"/>
              <a:ext cx="45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Calibri"/>
                </a:rPr>
                <a:t>Gud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hteck 44"/>
            <p:cNvSpPr/>
            <p:nvPr/>
          </p:nvSpPr>
          <p:spPr>
            <a:xfrm>
              <a:off x="4326840" y="1500120"/>
              <a:ext cx="540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alibri"/>
                </a:rPr>
                <a:t>Biasca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1" name="Textfeld 133"/>
          <p:cNvSpPr/>
          <p:nvPr/>
        </p:nvSpPr>
        <p:spPr>
          <a:xfrm>
            <a:off x="69840" y="212760"/>
            <a:ext cx="849636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Appendix S2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Johannesen J, Foissac X, Kehrli P, Maixner M: Impact of vector dispersal and host-plant fidelity on the dissemination of an emerging plant pathogen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"/>
          <p:cNvSpPr/>
          <p:nvPr/>
        </p:nvSpPr>
        <p:spPr>
          <a:xfrm>
            <a:off x="176040" y="1135800"/>
            <a:ext cx="3440160" cy="10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ampling sites of the stolbur vector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H. obsoletu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in Italy, South Switzerland (Ticino), Slovenia, Croatia and Austria. Stolbur isolates were obtained from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H. obsoletu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locations in italics.* Sample sites from [32]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31T08:57:55Z</dcterms:created>
  <dc:creator>Bianca &amp; Jes Johannesen</dc:creator>
  <dc:description/>
  <dc:language>en-US</dc:language>
  <cp:lastModifiedBy>jesjo</cp:lastModifiedBy>
  <dcterms:modified xsi:type="dcterms:W3CDTF">2012-11-23T10:42:39Z</dcterms:modified>
  <cp:revision>44</cp:revision>
  <dc:subject/>
  <dc:title>Folie 1</dc:title>
</cp:coreProperties>
</file>